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46" autoAdjust="0"/>
    <p:restoredTop sz="96143"/>
  </p:normalViewPr>
  <p:slideViewPr>
    <p:cSldViewPr snapToGrid="0">
      <p:cViewPr varScale="1">
        <p:scale>
          <a:sx n="122" d="100"/>
          <a:sy n="122" d="100"/>
        </p:scale>
        <p:origin x="344" y="192"/>
      </p:cViewPr>
      <p:guideLst/>
    </p:cSldViewPr>
  </p:slideViewPr>
  <p:notesTextViewPr>
    <p:cViewPr>
      <p:scale>
        <a:sx n="165" d="100"/>
        <a:sy n="16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5D0798-2E90-364B-9B2C-08870FF04CB2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97EAA6-CC5A-D149-8724-CD6098F7BB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3162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/>
              <a:t>東さん　</a:t>
            </a:r>
            <a:r>
              <a:rPr kumimoji="1" lang="en-US" altLang="ja-JP" dirty="0"/>
              <a:t>ET, 75</a:t>
            </a:r>
            <a:r>
              <a:rPr kumimoji="1" lang="ja-JP" altLang="en-US"/>
              <a:t>歳男性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97EAA6-CC5A-D149-8724-CD6098F7BB1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369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0166EC-1018-41F3-B3CC-249F80F9D8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47375E3-2B32-49D6-A488-65ECD1FD5D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C3491A-077C-42B3-A117-30FF02026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379E74-D66B-4B6D-B489-606083B92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6B9EB8-5A37-4816-8D69-0A3A0F889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4721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FC9A32-EB08-43AF-9B42-9C953D537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C7B0CBB-F6DD-40CD-90A4-36FAD915B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ED6CBF-E8A0-4D93-A07F-B662A2E9E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1D4428-3ECF-4076-B663-21EC89BD0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02EF18-7198-4327-A7BE-ADFE00F40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511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5AC4B57-90ED-4D45-87A7-624FD15870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32FA161-701A-443C-9048-7F9D13B662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7F0F5F-3004-4800-8CA6-8028D1C26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DFF63B-EA68-4CF8-87EB-00418898A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1CC977-3594-425B-AA62-118561537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663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F8B473-224F-41F8-99F3-9053F6FFF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5F95741-E712-46B4-93F7-293CF544A6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3F31729-2288-4B2B-9FDC-55F8EFE9D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6445D1-6ED4-46F4-81E5-3F2CC9043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87D828-C85B-4FE7-B158-D8C1E4178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2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5C0207-5CF0-45D4-86EA-F7F26E91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50D5E7D-3D97-4EF3-B5B5-6DC393043E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DECCB9-5B83-453C-B99A-0E8E81779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E33932-B278-4ACD-B8C0-F106768D4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536D34-7D04-4A6E-A056-A19ED91FA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5959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209EB1-0C94-49FC-93D4-D0D743402D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47C3254-1F08-4473-8048-60F6EA9AD7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5C90648-39CD-47C4-9C14-8783BFE5C2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BBB9F13-9BDA-45BC-8637-14E785D17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08A618-7108-46F6-88C8-2E23F3A74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CFC5BB-A9D0-4126-92FB-FFDB6E927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220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099450-1D7A-4D3D-BFBA-48A6B39D7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180C936-A07E-4DCB-BE1B-B485F1C1E1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AAEFBCC-A13A-4C8F-A7A5-AD99BD1D00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071F4C7-B794-41FF-8FA1-975FB0B874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761E53B-118F-4B64-9EED-B4D076735F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63A0435-95BF-4DEB-923E-8CD30C790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13CDC71-B1FF-42D3-8073-1142D228B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107A9F3-F142-430D-863E-874DBE65D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24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7DF8AC-700B-4885-9068-FF2DC472D9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30B9B9A-9DBA-453A-AA80-0423D06FD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2B35256-5561-40BD-8CDD-156FA7C29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03964D3-7338-43CE-A35B-F446A18F0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827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E936371-DBB9-4A17-80DE-07032B380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E412E8E-9275-457F-BA94-417550E3D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0023696-84CE-487F-B5E6-7B245D992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228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6938D1-3353-4561-A356-CF768BA228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F230629-C098-48E1-AB55-6E3F73B2E7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ADE59F-EC4B-4E91-A7D4-A3442716D7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C3FD8EE-39BC-4EDB-BAC0-8A653A813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EC8C58-E7DE-4049-8D79-C1CB3C56A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9E52B97-46B7-4BC4-8FF6-009DCFD89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2827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586073-7204-48D2-9603-B0082EC73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F4A4BBE-5868-4CB0-8A6E-3DFC7DD05F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A383428-3F38-4AAC-B1F1-1C1AA75D22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3271C28-168B-4054-8ADE-438826305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14A55F3-E68A-463E-90CC-26DE7D3F0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32C750-4F6B-450D-ABEC-83D35FEBA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9277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53587B0-7BA0-4A75-8A57-67A6B9143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97292BC-4A9D-427B-89C0-64A16418F8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A3F84D-54FE-4CF0-84D8-9B95B5AC22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347E2-B25A-4DDA-9501-27D83A8FEFAF}" type="datetimeFigureOut">
              <a:rPr kumimoji="1" lang="ja-JP" altLang="en-US" smtClean="0"/>
              <a:t>2024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3F1CFD-3233-461E-905A-DFCF7B76BD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A18F22-DB2C-405C-89CE-EF90A20629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5F537-2A65-4970-B85A-78441B409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113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D90FA5E8-BBBC-2D6E-17D7-6F5A00731B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2508" y="762689"/>
            <a:ext cx="3654343" cy="354402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5539EB38-2506-493C-A9E6-B96240AD16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7232" y="763696"/>
            <a:ext cx="3671225" cy="3539367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F1870EE-966C-4756-8CA6-225880166C6F}"/>
              </a:ext>
            </a:extLst>
          </p:cNvPr>
          <p:cNvSpPr txBox="1"/>
          <p:nvPr/>
        </p:nvSpPr>
        <p:spPr>
          <a:xfrm>
            <a:off x="1519699" y="4094547"/>
            <a:ext cx="381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61674E5-282B-4A37-BFF6-2C5148AB4D43}"/>
              </a:ext>
            </a:extLst>
          </p:cNvPr>
          <p:cNvSpPr txBox="1"/>
          <p:nvPr/>
        </p:nvSpPr>
        <p:spPr>
          <a:xfrm>
            <a:off x="1036178" y="760047"/>
            <a:ext cx="865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00%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C07815A-5AED-484E-801C-58EB784268D9}"/>
              </a:ext>
            </a:extLst>
          </p:cNvPr>
          <p:cNvSpPr txBox="1"/>
          <p:nvPr/>
        </p:nvSpPr>
        <p:spPr>
          <a:xfrm>
            <a:off x="4144131" y="2758579"/>
            <a:ext cx="298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33A775D-7260-970F-0EF8-F4C721197686}"/>
              </a:ext>
            </a:extLst>
          </p:cNvPr>
          <p:cNvSpPr txBox="1"/>
          <p:nvPr/>
        </p:nvSpPr>
        <p:spPr>
          <a:xfrm>
            <a:off x="7639573" y="2738768"/>
            <a:ext cx="298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337E3A-36C7-D822-027E-25A0E05D221B}"/>
              </a:ext>
            </a:extLst>
          </p:cNvPr>
          <p:cNvSpPr txBox="1"/>
          <p:nvPr/>
        </p:nvSpPr>
        <p:spPr>
          <a:xfrm>
            <a:off x="3734208" y="2181311"/>
            <a:ext cx="309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18036EA-2E32-03B2-9A81-BD66C5317E3F}"/>
              </a:ext>
            </a:extLst>
          </p:cNvPr>
          <p:cNvSpPr txBox="1"/>
          <p:nvPr/>
        </p:nvSpPr>
        <p:spPr>
          <a:xfrm>
            <a:off x="7233910" y="2176710"/>
            <a:ext cx="309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9C37BB9-8ECF-7578-AB76-BC8CC4107D8B}"/>
              </a:ext>
            </a:extLst>
          </p:cNvPr>
          <p:cNvSpPr txBox="1"/>
          <p:nvPr/>
        </p:nvSpPr>
        <p:spPr>
          <a:xfrm>
            <a:off x="3060624" y="988715"/>
            <a:ext cx="1585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rly image</a:t>
            </a:r>
            <a:endParaRPr kumimoji="1" lang="ja-JP" altLang="en-US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DEF467F-B3DC-1617-60FC-5791DA0975E7}"/>
              </a:ext>
            </a:extLst>
          </p:cNvPr>
          <p:cNvSpPr txBox="1"/>
          <p:nvPr/>
        </p:nvSpPr>
        <p:spPr>
          <a:xfrm>
            <a:off x="6338072" y="988715"/>
            <a:ext cx="1867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ayed</a:t>
            </a:r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mage</a:t>
            </a:r>
            <a:endParaRPr kumimoji="1" lang="ja-JP" altLang="en-US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FF1BFB3-61F1-7290-360B-65C5D1E1D686}"/>
              </a:ext>
            </a:extLst>
          </p:cNvPr>
          <p:cNvSpPr txBox="1"/>
          <p:nvPr/>
        </p:nvSpPr>
        <p:spPr>
          <a:xfrm>
            <a:off x="144322" y="137142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ure 1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8CE678A-2FF8-72C8-1619-3553168E7407}"/>
              </a:ext>
            </a:extLst>
          </p:cNvPr>
          <p:cNvSpPr txBox="1"/>
          <p:nvPr/>
        </p:nvSpPr>
        <p:spPr>
          <a:xfrm>
            <a:off x="7828287" y="4453047"/>
            <a:ext cx="740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MS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3D42C05-2E70-8166-EFF0-42CB02DB44AD}"/>
              </a:ext>
            </a:extLst>
          </p:cNvPr>
          <p:cNvSpPr txBox="1"/>
          <p:nvPr/>
        </p:nvSpPr>
        <p:spPr>
          <a:xfrm>
            <a:off x="2512536" y="4407503"/>
            <a:ext cx="7986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RBD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6A03F1C-C88E-DEAA-578F-0B76E5A44174}"/>
              </a:ext>
            </a:extLst>
          </p:cNvPr>
          <p:cNvSpPr txBox="1"/>
          <p:nvPr/>
        </p:nvSpPr>
        <p:spPr>
          <a:xfrm>
            <a:off x="4357282" y="4426816"/>
            <a:ext cx="5421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PD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5" descr="C:\Users\miyatomo\Desktop\RBD book\MSA.jpg">
            <a:extLst>
              <a:ext uri="{FF2B5EF4-FFF2-40B4-BE49-F238E27FC236}">
                <a16:creationId xmlns:a16="http://schemas.microsoft.com/office/drawing/2014/main" id="{20261587-7AE3-1C99-4D19-348698C0E1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75676" y="4807163"/>
            <a:ext cx="1781175" cy="1609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6" descr="C:\Users\miyatomo\Desktop\RBD book\IRBD.jpg">
            <a:extLst>
              <a:ext uri="{FF2B5EF4-FFF2-40B4-BE49-F238E27FC236}">
                <a16:creationId xmlns:a16="http://schemas.microsoft.com/office/drawing/2014/main" id="{34FB29FB-361E-D795-1E79-E02DF6A4EE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7072" y="4795787"/>
            <a:ext cx="1800225" cy="1619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7" descr="C:\Users\miyatomo\Desktop\RBD book\PD with RBD.jpg">
            <a:extLst>
              <a:ext uri="{FF2B5EF4-FFF2-40B4-BE49-F238E27FC236}">
                <a16:creationId xmlns:a16="http://schemas.microsoft.com/office/drawing/2014/main" id="{352941B7-45A1-897C-C77E-10E44511F7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7284" y="4807163"/>
            <a:ext cx="1809750" cy="1609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B2959AB-932F-A509-1672-A0ED19B53CFC}"/>
              </a:ext>
            </a:extLst>
          </p:cNvPr>
          <p:cNvSpPr txBox="1"/>
          <p:nvPr/>
        </p:nvSpPr>
        <p:spPr>
          <a:xfrm>
            <a:off x="6075459" y="4445285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LB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2" descr="C:\Users\miyatomo\Desktop\RBD book\delayed image\DLB.jpg">
            <a:extLst>
              <a:ext uri="{FF2B5EF4-FFF2-40B4-BE49-F238E27FC236}">
                <a16:creationId xmlns:a16="http://schemas.microsoft.com/office/drawing/2014/main" id="{4CC48C14-7473-6603-7E4D-FFE7FFE285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7484" y="4795787"/>
            <a:ext cx="1781175" cy="1619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A2D30B8-B08E-418C-F5E4-BD2109049CD0}"/>
              </a:ext>
            </a:extLst>
          </p:cNvPr>
          <p:cNvSpPr txBox="1"/>
          <p:nvPr/>
        </p:nvSpPr>
        <p:spPr>
          <a:xfrm>
            <a:off x="1519699" y="6270780"/>
            <a:ext cx="434734" cy="2522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67949CF-25AB-0C65-B44E-84CC220E1A72}"/>
              </a:ext>
            </a:extLst>
          </p:cNvPr>
          <p:cNvSpPr txBox="1"/>
          <p:nvPr/>
        </p:nvSpPr>
        <p:spPr>
          <a:xfrm>
            <a:off x="1080103" y="4745428"/>
            <a:ext cx="865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00%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7C9554E-2D50-4C82-14DB-86559ACDF1BE}"/>
              </a:ext>
            </a:extLst>
          </p:cNvPr>
          <p:cNvSpPr txBox="1"/>
          <p:nvPr/>
        </p:nvSpPr>
        <p:spPr>
          <a:xfrm>
            <a:off x="9098894" y="3968612"/>
            <a:ext cx="2646678" cy="2492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Planar H/M ratio </a:t>
            </a:r>
            <a:r>
              <a:rPr lang="en-US" altLang="ja-JP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semiquantification</a:t>
            </a:r>
            <a:r>
              <a:rPr lang="en-US" altLang="ja-JP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of 123I-MIBG uptake on the anterior view of the thorax. </a:t>
            </a:r>
          </a:p>
          <a:p>
            <a:endParaRPr lang="ja-JP" altLang="ja-JP" sz="1200" b="1"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  <a:p>
            <a:r>
              <a:rPr lang="en-US" altLang="ja-JP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Upper panel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: 123I-MIBG early or delayed H/M ratio in control subject.</a:t>
            </a:r>
            <a:endParaRPr lang="ja-JP" altLang="ja-JP" sz="1200"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  <a:p>
            <a:r>
              <a:rPr lang="en-US" altLang="ja-JP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Lower panel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: 123I-MIBG delayed H/M ratio in isolated REM sleep behavior disorder (IRBD), Parkinson’s disease (PD), dementia with Lewy bodies (DLB), and multiple systemic atrophy (MSA).</a:t>
            </a:r>
            <a:endParaRPr lang="ja-JP" altLang="ja-JP" sz="1200"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4807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98</Words>
  <Application>Microsoft Macintosh PowerPoint</Application>
  <PresentationFormat>ワイド画面</PresentationFormat>
  <Paragraphs>2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智之 宮本</dc:creator>
  <cp:lastModifiedBy>宮本　智之</cp:lastModifiedBy>
  <cp:revision>12</cp:revision>
  <dcterms:created xsi:type="dcterms:W3CDTF">2024-01-27T05:18:19Z</dcterms:created>
  <dcterms:modified xsi:type="dcterms:W3CDTF">2024-04-09T00:11:36Z</dcterms:modified>
</cp:coreProperties>
</file>